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660"/>
  </p:normalViewPr>
  <p:slideViewPr>
    <p:cSldViewPr snapToGrid="0">
      <p:cViewPr varScale="1">
        <p:scale>
          <a:sx n="98" d="100"/>
          <a:sy n="98" d="100"/>
        </p:scale>
        <p:origin x="84" y="5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5E96A2-1A89-54B1-B110-C633631766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0AC1399-BE0B-4833-988C-A2A8255FB8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F6D788-88D3-FEE7-07F0-3F3C31F1C7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2F98F-B689-4B07-AAF5-32D66EB3FB1E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19ED44-21A5-E260-4318-C37A32B56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E99913-AC83-E9D1-67F1-70664FB521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6FA02-3928-4051-BE40-8AF431C2D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4147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4D2B0F-048A-AEF6-0BB2-F2F899EB76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892752-BC17-4C36-B1E5-FD9E9360BE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BE9917-4E0D-9332-2A19-71DDCD60D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2F98F-B689-4B07-AAF5-32D66EB3FB1E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70BBB9-533D-CE74-3BC6-490F302307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4E6CE2-A0E0-EA4F-A8EB-F11B705B6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6FA02-3928-4051-BE40-8AF431C2D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5002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8904C5C-9412-A7BF-7630-6FC9859E1EE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F5CF53-D395-1AF3-4065-21B8EB97E8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AED100-18E1-CA24-0EEB-71C68CE14C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2F98F-B689-4B07-AAF5-32D66EB3FB1E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99F4C2-4AFD-B78E-5025-DEF13A8334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FD6F78-D606-987B-B447-AA09E4C980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6FA02-3928-4051-BE40-8AF431C2D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3474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4E1DDA-9C5D-6A8C-C335-63DC0EE5D6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42A502-CC8C-5689-3B1E-CC8EBD1C0C0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7E7EC3-1735-D0DE-2821-8D5C9AF798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2F98F-B689-4B07-AAF5-32D66EB3FB1E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C23640-BA1D-F98B-7780-9F12EE015C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41538B-8A98-8E51-D256-A00AC19B68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6FA02-3928-4051-BE40-8AF431C2D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3096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8659E7-C165-2A1F-2FE6-68C9744A35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F475CB-3979-1FF1-AB11-EFD373A305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3D347F-D9E2-554B-B2C3-BED1D25EF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2F98F-B689-4B07-AAF5-32D66EB3FB1E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7C42CE-44AA-159F-C60A-5898485BC6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02D000-2670-159A-0911-E536FA613F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6FA02-3928-4051-BE40-8AF431C2D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8095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5EECE1-2F45-6EE0-36F5-655AC7F9BD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DD3193-2AE4-EB8F-E81F-737FB37CFC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0CD727-BE38-4AC7-EDBE-0A9216480D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34F0E0-9190-7CC8-2E88-2821B800FD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2F98F-B689-4B07-AAF5-32D66EB3FB1E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C2C8F7-03E5-CF69-5F55-F1FEF68472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63B53A-0EA0-6AED-9828-DD1228F1C2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6FA02-3928-4051-BE40-8AF431C2D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822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C7020D-677B-DC0E-5E07-796FB51F56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CC14E0-AB99-E9D8-6431-EDBBBD6EE5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37F1F27-AB61-BEE9-AADE-03A91DE0B2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2F860D7-0C34-C633-9DB9-A077347071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65629D8-ACDA-F3A5-B75F-5A5599103FD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D359CBF-CFBA-739D-DF2B-8367B2DA2D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2F98F-B689-4B07-AAF5-32D66EB3FB1E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FD55AEA-2B29-A164-35A4-5C39231ADB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57155EA-D4EE-DB7F-44B5-4E5C1B2891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6FA02-3928-4051-BE40-8AF431C2D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35912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92BCD8-1915-3539-143D-867A14C310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3C41EE7-A909-ECF9-569C-6C062119DE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2F98F-B689-4B07-AAF5-32D66EB3FB1E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9768180-2DA5-6016-3E0C-4F6D999C03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8F21A88-56B5-524C-848D-2E2703D2D5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6FA02-3928-4051-BE40-8AF431C2D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5897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428402E-CE68-73C6-FEE8-F6DDF7C70B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2F98F-B689-4B07-AAF5-32D66EB3FB1E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2302F22-AF1B-46E7-A53A-3CF70E8F78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934251E-7E5E-A9C6-845A-9DF882D153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6FA02-3928-4051-BE40-8AF431C2D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0406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F2ABC7-7D8C-60B4-C595-97003FC797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AF9A96-2D86-F092-E745-08991806D2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BFC0C4C-85B4-1857-B2AD-000E81589A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85E3E9-2505-708F-486E-9E88DDD441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2F98F-B689-4B07-AAF5-32D66EB3FB1E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08E937-05A2-BA06-2BB3-C657A3A50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EF5908-5594-1BD7-62E0-87DCAB5206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6FA02-3928-4051-BE40-8AF431C2D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3890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992444-5170-7C8F-EBEB-BB1D841B05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3C9B746-46E3-8F91-071E-CA2BD6AFE7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D2B20A-24D0-B67E-27D2-B111E96E9B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9FC89A-3A04-E72F-3E86-8E78F3128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2F98F-B689-4B07-AAF5-32D66EB3FB1E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C2CD03-3241-3250-8564-89E7C243C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54C10F-DEF2-DFAB-2A96-7636C488CE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6FA02-3928-4051-BE40-8AF431C2D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1686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BA11AD9-F16E-76E6-58EA-339131834D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53BA24-78DE-E65E-76BA-9BAB279919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6DF3D6-9A32-1082-E397-4BFBC5368F3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8F2F98F-B689-4B07-AAF5-32D66EB3FB1E}" type="datetimeFigureOut">
              <a:rPr lang="en-US" smtClean="0"/>
              <a:t>2/15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044F4B-DAAF-5049-A84D-73DFBB210A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4EDCA0-B56E-B5D3-7761-0D554E5C0B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926FA02-3928-4051-BE40-8AF431C2DF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8960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1">
            <a:extLst>
              <a:ext uri="{FF2B5EF4-FFF2-40B4-BE49-F238E27FC236}">
                <a16:creationId xmlns:a16="http://schemas.microsoft.com/office/drawing/2014/main" id="{A51A19B7-C3D4-E637-C2C0-B51AA8FD1889}"/>
              </a:ext>
            </a:extLst>
          </p:cNvPr>
          <p:cNvSpPr txBox="1"/>
          <p:nvPr/>
        </p:nvSpPr>
        <p:spPr>
          <a:xfrm>
            <a:off x="3373139" y="3974057"/>
            <a:ext cx="6088526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/>
              <a:t>Supplementary Figure S1.	Panel A shows the length distribution of non-redundant </a:t>
            </a:r>
            <a:r>
              <a:rPr lang="en-US" sz="1000" dirty="0" err="1"/>
              <a:t>Unigenes</a:t>
            </a:r>
            <a:r>
              <a:rPr lang="en-US" sz="1000" dirty="0"/>
              <a:t>. Panel B</a:t>
            </a:r>
          </a:p>
          <a:p>
            <a:r>
              <a:rPr lang="en-US" sz="1000" dirty="0"/>
              <a:t>is an Alfa Diversity rarefaction curve showing the number of species richness on the three</a:t>
            </a:r>
          </a:p>
          <a:p>
            <a:r>
              <a:rPr lang="en-US" sz="1000" dirty="0"/>
              <a:t>investigated biofilms. The flatten  curves indicates that the amount of sequenced data gradually</a:t>
            </a:r>
          </a:p>
          <a:p>
            <a:r>
              <a:rPr lang="en-US" sz="1000" dirty="0"/>
              <a:t>become stable, and more data likely will yield few new information. The horizontal axis denotes</a:t>
            </a:r>
          </a:p>
          <a:p>
            <a:r>
              <a:rPr lang="en-US" sz="1000" dirty="0"/>
              <a:t>the number randomly sampled sequences, whereas the vertical axis represents the species</a:t>
            </a:r>
          </a:p>
          <a:p>
            <a:r>
              <a:rPr lang="en-US" sz="1000" dirty="0"/>
              <a:t>abundance for each sample (color) when the same number of sequences are sampled.  </a:t>
            </a:r>
          </a:p>
          <a:p>
            <a:endParaRPr lang="en-US" sz="1000" dirty="0"/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B8E9BF4A-8DB2-B19B-0314-AA672357BCA6}"/>
              </a:ext>
            </a:extLst>
          </p:cNvPr>
          <p:cNvGrpSpPr/>
          <p:nvPr/>
        </p:nvGrpSpPr>
        <p:grpSpPr>
          <a:xfrm>
            <a:off x="3619030" y="1714392"/>
            <a:ext cx="5066943" cy="2155264"/>
            <a:chOff x="828245" y="3255703"/>
            <a:chExt cx="5066943" cy="2155264"/>
          </a:xfrm>
        </p:grpSpPr>
        <p:pic>
          <p:nvPicPr>
            <p:cNvPr id="7" name="Picture 6" descr="A yellow line on a black background&#10;&#10;AI-generated content may be incorrect.">
              <a:extLst>
                <a:ext uri="{FF2B5EF4-FFF2-40B4-BE49-F238E27FC236}">
                  <a16:creationId xmlns:a16="http://schemas.microsoft.com/office/drawing/2014/main" id="{47602BF4-2F1A-8AA4-7277-132421C92CF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7407"/>
            <a:stretch/>
          </p:blipFill>
          <p:spPr>
            <a:xfrm>
              <a:off x="828245" y="3268699"/>
              <a:ext cx="2644775" cy="2142268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7E3FF33A-699E-1E29-C874-1B230B53663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10557" t="5090" r="1666" b="3702"/>
            <a:stretch/>
          </p:blipFill>
          <p:spPr>
            <a:xfrm>
              <a:off x="3406345" y="3255703"/>
              <a:ext cx="2488843" cy="2155263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8411115-630C-FC62-58D4-AC5602F59996}"/>
                </a:ext>
              </a:extLst>
            </p:cNvPr>
            <p:cNvSpPr txBox="1"/>
            <p:nvPr/>
          </p:nvSpPr>
          <p:spPr>
            <a:xfrm>
              <a:off x="991606" y="3268698"/>
              <a:ext cx="27751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b="1" dirty="0"/>
                <a:t>A					   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649988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00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endoza, Alberto</dc:creator>
  <cp:lastModifiedBy>Mendoza, Alberto</cp:lastModifiedBy>
  <cp:revision>1</cp:revision>
  <dcterms:created xsi:type="dcterms:W3CDTF">2026-02-15T23:26:13Z</dcterms:created>
  <dcterms:modified xsi:type="dcterms:W3CDTF">2026-02-15T23:27:56Z</dcterms:modified>
</cp:coreProperties>
</file>